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4BC021-8BFB-4828-B7AA-575C2CAAD02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22804E-802D-47BA-B4D8-35182A40F2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350F9E-EF09-4163-80BF-1B884E70F84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20BC36-38C1-4AF4-A34A-F76383A17AB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5A4268-591E-40C4-860C-EA084CF8A8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5C9D81-C51E-434E-B0B7-220182CCAE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0EEBB8-36FC-4407-BC33-6577B27954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7DF772-549A-4BF9-8D51-D634AE63A3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94C010-CA62-4E44-AB2B-802C257231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F17D63-226C-4195-8D45-F6CCA0D477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3DF736-27A5-4960-A7E9-458C9C46D6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CAAB73-8EB6-4384-85F1-4A4A1E7C77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FF6727F-0557-47D0-AB17-82397E6F6D62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8A25B09-1B1B-469E-835A-62760478B28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5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368280" y="0"/>
            <a:ext cx="3238560" cy="220968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5" descr=""/>
          <p:cNvPicPr/>
          <p:nvPr/>
        </p:nvPicPr>
        <p:blipFill>
          <a:blip r:embed="rId2"/>
          <a:stretch/>
        </p:blipFill>
        <p:spPr>
          <a:xfrm>
            <a:off x="0" y="2171880"/>
            <a:ext cx="3327480" cy="22176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6" descr=""/>
          <p:cNvPicPr/>
          <p:nvPr/>
        </p:nvPicPr>
        <p:blipFill>
          <a:blip r:embed="rId3"/>
          <a:stretch/>
        </p:blipFill>
        <p:spPr>
          <a:xfrm>
            <a:off x="0" y="4375080"/>
            <a:ext cx="3336840" cy="217800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7" descr=""/>
          <p:cNvPicPr/>
          <p:nvPr/>
        </p:nvPicPr>
        <p:blipFill>
          <a:blip r:embed="rId4"/>
          <a:stretch/>
        </p:blipFill>
        <p:spPr>
          <a:xfrm>
            <a:off x="3606840" y="0"/>
            <a:ext cx="3139920" cy="220968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8" descr=""/>
          <p:cNvPicPr/>
          <p:nvPr/>
        </p:nvPicPr>
        <p:blipFill>
          <a:blip r:embed="rId5"/>
          <a:stretch/>
        </p:blipFill>
        <p:spPr>
          <a:xfrm>
            <a:off x="3336840" y="2184480"/>
            <a:ext cx="3427560" cy="221760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9" descr=""/>
          <p:cNvPicPr/>
          <p:nvPr/>
        </p:nvPicPr>
        <p:blipFill>
          <a:blip r:embed="rId6"/>
          <a:stretch/>
        </p:blipFill>
        <p:spPr>
          <a:xfrm>
            <a:off x="3349800" y="4375080"/>
            <a:ext cx="3427200" cy="2217960"/>
          </a:xfrm>
          <a:prstGeom prst="rect">
            <a:avLst/>
          </a:prstGeom>
          <a:ln w="0">
            <a:noFill/>
          </a:ln>
        </p:spPr>
      </p:pic>
      <p:sp>
        <p:nvSpPr>
          <p:cNvPr id="47" name="TextBox 10"/>
          <p:cNvSpPr/>
          <p:nvPr/>
        </p:nvSpPr>
        <p:spPr>
          <a:xfrm>
            <a:off x="1767240" y="230040"/>
            <a:ext cx="52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PK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1"/>
          <p:cNvSpPr/>
          <p:nvPr/>
        </p:nvSpPr>
        <p:spPr>
          <a:xfrm>
            <a:off x="1554120" y="2441520"/>
            <a:ext cx="102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PK-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ennai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2"/>
          <p:cNvSpPr/>
          <p:nvPr/>
        </p:nvSpPr>
        <p:spPr>
          <a:xfrm>
            <a:off x="1429920" y="4702320"/>
            <a:ext cx="85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PK-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lhi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3"/>
          <p:cNvSpPr/>
          <p:nvPr/>
        </p:nvSpPr>
        <p:spPr>
          <a:xfrm>
            <a:off x="4588920" y="230040"/>
            <a:ext cx="959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PK-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adiad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4"/>
          <p:cNvSpPr/>
          <p:nvPr/>
        </p:nvSpPr>
        <p:spPr>
          <a:xfrm>
            <a:off x="4590360" y="2441520"/>
            <a:ext cx="878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PK-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nn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5"/>
          <p:cNvSpPr/>
          <p:nvPr/>
        </p:nvSpPr>
        <p:spPr>
          <a:xfrm>
            <a:off x="4654080" y="4702320"/>
            <a:ext cx="997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PK-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amru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6"/>
          <p:cNvSpPr/>
          <p:nvPr/>
        </p:nvSpPr>
        <p:spPr>
          <a:xfrm rot="16200000">
            <a:off x="-135360" y="878040"/>
            <a:ext cx="790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requency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6"/>
          <p:cNvSpPr/>
          <p:nvPr/>
        </p:nvSpPr>
        <p:spPr>
          <a:xfrm>
            <a:off x="6850080" y="2687760"/>
            <a:ext cx="21160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3: 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Expected and observed pairwise differences at housekeeping gene in </a:t>
            </a:r>
            <a:r>
              <a:rPr b="0" i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P. vivax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 population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27T06:49:37Z</dcterms:created>
  <dc:creator>Surendra Kumar  Prajapati</dc:creator>
  <dc:description/>
  <dc:language>en-US</dc:language>
  <cp:lastModifiedBy>Surendra Kumar  Prajapati</cp:lastModifiedBy>
  <dcterms:modified xsi:type="dcterms:W3CDTF">2013-08-20T15:17:11Z</dcterms:modified>
  <cp:revision>15</cp:revision>
  <dc:subject/>
  <dc:title>Slide 1</dc:title>
</cp:coreProperties>
</file>